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4663"/>
  </p:normalViewPr>
  <p:slideViewPr>
    <p:cSldViewPr snapToGrid="0" snapToObjects="1" showGuides="1">
      <p:cViewPr>
        <p:scale>
          <a:sx n="156" d="100"/>
          <a:sy n="156" d="100"/>
        </p:scale>
        <p:origin x="1384" y="14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2EEC5-F828-FA43-88DC-794BCF84CACE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843A1-7F54-FC4F-B233-4B60DDC7F5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99912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2EEC5-F828-FA43-88DC-794BCF84CACE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843A1-7F54-FC4F-B233-4B60DDC7F5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33441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2EEC5-F828-FA43-88DC-794BCF84CACE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843A1-7F54-FC4F-B233-4B60DDC7F5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39575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2EEC5-F828-FA43-88DC-794BCF84CACE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843A1-7F54-FC4F-B233-4B60DDC7F5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37498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2EEC5-F828-FA43-88DC-794BCF84CACE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843A1-7F54-FC4F-B233-4B60DDC7F5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87512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2EEC5-F828-FA43-88DC-794BCF84CACE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843A1-7F54-FC4F-B233-4B60DDC7F5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88717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2EEC5-F828-FA43-88DC-794BCF84CACE}" type="datetimeFigureOut">
              <a:rPr lang="en-US" smtClean="0"/>
              <a:t>5/27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843A1-7F54-FC4F-B233-4B60DDC7F5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95641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2EEC5-F828-FA43-88DC-794BCF84CACE}" type="datetimeFigureOut">
              <a:rPr lang="en-US" smtClean="0"/>
              <a:t>5/27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843A1-7F54-FC4F-B233-4B60DDC7F5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26075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2EEC5-F828-FA43-88DC-794BCF84CACE}" type="datetimeFigureOut">
              <a:rPr lang="en-US" smtClean="0"/>
              <a:t>5/27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843A1-7F54-FC4F-B233-4B60DDC7F5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2347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2EEC5-F828-FA43-88DC-794BCF84CACE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843A1-7F54-FC4F-B233-4B60DDC7F5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1561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2EEC5-F828-FA43-88DC-794BCF84CACE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843A1-7F54-FC4F-B233-4B60DDC7F5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92074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52EEC5-F828-FA43-88DC-794BCF84CACE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9843A1-7F54-FC4F-B233-4B60DDC7F5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15542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416EC46E-DEAE-574A-B767-AF4622A3CA4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47915242"/>
              </p:ext>
            </p:extLst>
          </p:nvPr>
        </p:nvGraphicFramePr>
        <p:xfrm>
          <a:off x="1225232" y="1327338"/>
          <a:ext cx="4407535" cy="457200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987425">
                  <a:extLst>
                    <a:ext uri="{9D8B030D-6E8A-4147-A177-3AD203B41FA5}">
                      <a16:colId xmlns:a16="http://schemas.microsoft.com/office/drawing/2014/main" val="2862040348"/>
                    </a:ext>
                  </a:extLst>
                </a:gridCol>
                <a:gridCol w="3420110">
                  <a:extLst>
                    <a:ext uri="{9D8B030D-6E8A-4147-A177-3AD203B41FA5}">
                      <a16:colId xmlns:a16="http://schemas.microsoft.com/office/drawing/2014/main" val="31833773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ain name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otype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9601599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C5314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b="0" i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 albicans </a:t>
                      </a:r>
                      <a:r>
                        <a:rPr lang="en-IN" sz="1000" b="0" i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 strain </a:t>
                      </a: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Wild-type)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57815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A3404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IN" sz="1000" b="0" i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 tropicalis </a:t>
                      </a: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inical isolate (Wild-type)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426285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KS102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IN" sz="1000" b="0" i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a3::FRT/ura3::FRT his1::FRT/his1::FRT arg4::FRT/arg4::FRT CSE4/CSE4::CSE4-TAP (CaHIS1)</a:t>
                      </a:r>
                      <a:endParaRPr lang="en-IN" sz="1000" b="0" i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236262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KG001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IN" sz="1000" b="0" i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a3::FRT/ura3::FRT his1::FRT/his1::FRT arg4::FRT/arg4::FRT CSE4/CSE4::CSE4-TAP (CaHIS1) sch9::FRT/sch9::FRT</a:t>
                      </a:r>
                      <a:endParaRPr lang="en-IN" sz="1000" b="0" i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4731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KG002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IN" sz="1000" b="0" i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a3::FRT/ura3::FRT his1::FRT/his1::FRT arg4::FRT/arg4::FRT CSE4/CSE4::CSE4-TAP (CaHIS1) sch9::FRT/sch9::FRT Chr5-497kb/ Chr5-497kb::CaURA3</a:t>
                      </a:r>
                      <a:endParaRPr lang="en-IN" sz="1000" b="0" i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05684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KG003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b="0" i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a3::FRT/ura3::FRT his1::FRT/his1::FRT arg4::FRT/arg4::FRT CSE4/CSE4::CSE4-TAP (CaHIS1)</a:t>
                      </a:r>
                      <a:endParaRPr lang="en-IN" sz="1000" b="0" i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IN" sz="1000" b="0" i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5-497kb/ Chr5-497kb::CaURA3</a:t>
                      </a:r>
                      <a:endParaRPr lang="en-IN" sz="1000" b="0" i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2986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KG101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IN" sz="1000" b="0" i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a3::FRT/ura3::FRT his1::FRT/his1::FRT arg4::FRT/arg4::FRT CSE4/CSE4::CSE4-TAP (CaHIS1) sch9::FRT/sch9::FRT </a:t>
                      </a:r>
                      <a:r>
                        <a:rPr lang="en-IN" sz="1000" b="0" i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5</a:t>
                      </a:r>
                      <a:r>
                        <a:rPr lang="en-IN" sz="1000" b="0" i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IN" sz="1000" b="0" i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osomy Transformant 1</a:t>
                      </a:r>
                      <a:endParaRPr lang="en-IN" sz="1000" b="0" i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307707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KG102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IN" sz="1000" b="0" i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a3::FRT/ura3::FRT his1::FRT/his1::FRT arg4::FRT/arg4::FRT CSE4/CSE4::CSE4-TAP (CaHIS1) sch9::FRT/sch9::FRT </a:t>
                      </a:r>
                      <a:r>
                        <a:rPr lang="en-IN" sz="1000" b="0" i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5 monosomy Transformant 2</a:t>
                      </a:r>
                      <a:endParaRPr lang="en-IN" sz="1000" b="0" i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477370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KG103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IN" sz="1000" b="0" i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a3::FRT/ura3::FRT his1::FRT/his1::FRT arg4::FRT/arg4::FRT CSE4/CSE4::CSE4-TAP (CaHIS1) sch9::FRT/sch9::FRT </a:t>
                      </a:r>
                      <a:r>
                        <a:rPr lang="en-IN" sz="1000" b="0" i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5 monosomy Transformant 3</a:t>
                      </a:r>
                      <a:endParaRPr lang="en-IN" sz="1000" b="0" i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840565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KG104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IN" sz="1000" b="0" i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a3::FRT/ura3::FRT his1::FRT/his1::FRT arg4::FRT/arg4::FRT CSE4/CSE4::CSE4-TAP (CaHIS1) sch9::FRT/sch9::FRT </a:t>
                      </a:r>
                      <a:r>
                        <a:rPr lang="en-IN" sz="1000" b="0" i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5 monosomy Transformant 4</a:t>
                      </a:r>
                      <a:endParaRPr lang="en-IN" sz="1000" b="0" i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55346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KG105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IN" sz="1000" b="0" i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a3::FRT/ura3::FRT his1::FRT/his1::FRT arg4::FRT/arg4::FRT CSE4/CSE4::CSE4-TAP (CaHIS1) sch9::FRT/sch9::FRT </a:t>
                      </a:r>
                      <a:r>
                        <a:rPr lang="en-IN" sz="1000" b="0" i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5 monosomy Transformant 5</a:t>
                      </a:r>
                      <a:endParaRPr lang="en-IN" sz="1000" b="0" i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4311797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YC-2606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vironmental isolate of C. </a:t>
                      </a:r>
                      <a:r>
                        <a:rPr lang="en-IN" sz="1000" b="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jae</a:t>
                      </a: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wild-type)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40133537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E3A920D6-945E-B543-A639-E6C2BB0040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25232" y="927228"/>
            <a:ext cx="3223959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le 8: List of strains used in this study.</a:t>
            </a:r>
            <a:endParaRPr kumimoji="0" lang="en-US" altLang="en-US" sz="10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0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254771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92</Words>
  <Application>Microsoft Macintosh PowerPoint</Application>
  <PresentationFormat>A4 Paper (210x297 mm)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rishnendu guin</dc:creator>
  <cp:lastModifiedBy>krishnendu guin</cp:lastModifiedBy>
  <cp:revision>1</cp:revision>
  <dcterms:created xsi:type="dcterms:W3CDTF">2020-05-27T11:07:11Z</dcterms:created>
  <dcterms:modified xsi:type="dcterms:W3CDTF">2020-05-27T11:08:10Z</dcterms:modified>
</cp:coreProperties>
</file>